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9" d="100"/>
          <a:sy n="99" d="100"/>
        </p:scale>
        <p:origin x="-732" y="-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D79ED-3480-4B97-8997-A67FB440045B}" type="datetimeFigureOut">
              <a:rPr lang="nl-NL" smtClean="0"/>
              <a:t>12-6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D7AE1-C52A-4BDF-A5F4-A50211544D7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15312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D79ED-3480-4B97-8997-A67FB440045B}" type="datetimeFigureOut">
              <a:rPr lang="nl-NL" smtClean="0"/>
              <a:t>12-6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D7AE1-C52A-4BDF-A5F4-A50211544D7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2338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D79ED-3480-4B97-8997-A67FB440045B}" type="datetimeFigureOut">
              <a:rPr lang="nl-NL" smtClean="0"/>
              <a:t>12-6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D7AE1-C52A-4BDF-A5F4-A50211544D7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85003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D79ED-3480-4B97-8997-A67FB440045B}" type="datetimeFigureOut">
              <a:rPr lang="nl-NL" smtClean="0"/>
              <a:t>12-6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D7AE1-C52A-4BDF-A5F4-A50211544D7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97181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D79ED-3480-4B97-8997-A67FB440045B}" type="datetimeFigureOut">
              <a:rPr lang="nl-NL" smtClean="0"/>
              <a:t>12-6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D7AE1-C52A-4BDF-A5F4-A50211544D7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21557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D79ED-3480-4B97-8997-A67FB440045B}" type="datetimeFigureOut">
              <a:rPr lang="nl-NL" smtClean="0"/>
              <a:t>12-6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D7AE1-C52A-4BDF-A5F4-A50211544D7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19570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D79ED-3480-4B97-8997-A67FB440045B}" type="datetimeFigureOut">
              <a:rPr lang="nl-NL" smtClean="0"/>
              <a:t>12-6-2019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D7AE1-C52A-4BDF-A5F4-A50211544D7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566334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D79ED-3480-4B97-8997-A67FB440045B}" type="datetimeFigureOut">
              <a:rPr lang="nl-NL" smtClean="0"/>
              <a:t>12-6-2019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D7AE1-C52A-4BDF-A5F4-A50211544D7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17469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D79ED-3480-4B97-8997-A67FB440045B}" type="datetimeFigureOut">
              <a:rPr lang="nl-NL" smtClean="0"/>
              <a:t>12-6-2019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D7AE1-C52A-4BDF-A5F4-A50211544D7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04029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D79ED-3480-4B97-8997-A67FB440045B}" type="datetimeFigureOut">
              <a:rPr lang="nl-NL" smtClean="0"/>
              <a:t>12-6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D7AE1-C52A-4BDF-A5F4-A50211544D7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31977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D79ED-3480-4B97-8997-A67FB440045B}" type="datetimeFigureOut">
              <a:rPr lang="nl-NL" smtClean="0"/>
              <a:t>12-6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D7AE1-C52A-4BDF-A5F4-A50211544D7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407039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7D79ED-3480-4B97-8997-A67FB440045B}" type="datetimeFigureOut">
              <a:rPr lang="nl-NL" smtClean="0"/>
              <a:t>12-6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AD7AE1-C52A-4BDF-A5F4-A50211544D7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80720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3" Type="http://schemas.openxmlformats.org/officeDocument/2006/relationships/image" Target="../media/image18.jpeg"/><Relationship Id="rId7" Type="http://schemas.openxmlformats.org/officeDocument/2006/relationships/image" Target="../media/image22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jpeg"/><Relationship Id="rId5" Type="http://schemas.openxmlformats.org/officeDocument/2006/relationships/image" Target="../media/image20.jpeg"/><Relationship Id="rId10" Type="http://schemas.openxmlformats.org/officeDocument/2006/relationships/image" Target="../media/image25.jpeg"/><Relationship Id="rId4" Type="http://schemas.openxmlformats.org/officeDocument/2006/relationships/image" Target="../media/image19.jpeg"/><Relationship Id="rId9" Type="http://schemas.openxmlformats.org/officeDocument/2006/relationships/image" Target="../media/image24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jpeg"/><Relationship Id="rId3" Type="http://schemas.openxmlformats.org/officeDocument/2006/relationships/image" Target="../media/image27.jpeg"/><Relationship Id="rId7" Type="http://schemas.openxmlformats.org/officeDocument/2006/relationships/image" Target="../media/image31.jpeg"/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0.jpeg"/><Relationship Id="rId5" Type="http://schemas.openxmlformats.org/officeDocument/2006/relationships/image" Target="../media/image29.jpeg"/><Relationship Id="rId4" Type="http://schemas.openxmlformats.org/officeDocument/2006/relationships/image" Target="../media/image28.jpeg"/><Relationship Id="rId9" Type="http://schemas.openxmlformats.org/officeDocument/2006/relationships/image" Target="../media/image33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jpeg"/><Relationship Id="rId2" Type="http://schemas.openxmlformats.org/officeDocument/2006/relationships/image" Target="../media/image34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8.jpeg"/><Relationship Id="rId5" Type="http://schemas.openxmlformats.org/officeDocument/2006/relationships/image" Target="../media/image37.jpeg"/><Relationship Id="rId4" Type="http://schemas.openxmlformats.org/officeDocument/2006/relationships/image" Target="../media/image3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899593" y="685186"/>
            <a:ext cx="7430280" cy="5542085"/>
            <a:chOff x="899593" y="685186"/>
            <a:chExt cx="7430280" cy="5542085"/>
          </a:xfrm>
        </p:grpSpPr>
        <p:pic>
          <p:nvPicPr>
            <p:cNvPr id="1026" name="Picture 2" descr="15M20155803bewerkt rens"/>
            <p:cNvPicPr>
              <a:picLocks noChangeAspect="1" noChangeArrowheads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29825" y="1054549"/>
              <a:ext cx="2160000" cy="16168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7" name="Picture 3" descr="15SP20160355bewerkt rens"/>
            <p:cNvPicPr>
              <a:picLocks noChangeAspect="1" noChangeArrowheads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29825" y="2852936"/>
              <a:ext cx="2160000" cy="1620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8" name="Picture 4" descr="15SC21123054bewerkt rens"/>
            <p:cNvPicPr>
              <a:picLocks noChangeAspect="1" noChangeArrowheads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29825" y="4598284"/>
              <a:ext cx="2160000" cy="1628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1645850" y="692696"/>
              <a:ext cx="1488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Chondrogenic</a:t>
              </a:r>
              <a:endParaRPr lang="nl-NL" dirty="0"/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760292" y="1684947"/>
              <a:ext cx="6479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Flask</a:t>
              </a:r>
              <a:endParaRPr lang="nl-NL" dirty="0"/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632052" y="3457713"/>
              <a:ext cx="9044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smtClean="0"/>
                <a:t>Spinner</a:t>
              </a:r>
              <a:endParaRPr lang="nl-NL" dirty="0"/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696973" y="5228110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smtClean="0"/>
                <a:t>Scinus</a:t>
              </a:r>
              <a:endParaRPr lang="nl-NL" dirty="0"/>
            </a:p>
          </p:txBody>
        </p:sp>
        <p:pic>
          <p:nvPicPr>
            <p:cNvPr id="11" name="Picture 10" descr="C:\Users\marijnd\AppData\Local\Microsoft\Windows\INetCache\Content.Word\Adipo A1 200x (4).jpg"/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06090" y="1067766"/>
              <a:ext cx="2160000" cy="160369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" name="Picture 11" descr="C:\Users\marijnd\AppData\Local\Microsoft\Windows\INetCache\Content.Word\Adipo A2 200x (3).jpg"/>
            <p:cNvPicPr>
              <a:picLocks noChangeAspect="1"/>
            </p:cNvPicPr>
            <p:nvPr/>
          </p:nvPicPr>
          <p:blipFill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06090" y="2842127"/>
              <a:ext cx="2160000" cy="164242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3" name="Picture 12" descr="C:\Users\marijnd\AppData\Local\Microsoft\Windows\INetCache\Content.Word\Adipo A3 200x (3).jpg"/>
            <p:cNvPicPr>
              <a:picLocks noChangeAspect="1"/>
            </p:cNvPicPr>
            <p:nvPr/>
          </p:nvPicPr>
          <p:blipFill>
            <a:blip r:embed="rId7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06090" y="4603194"/>
              <a:ext cx="2160000" cy="162407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4" name="TextBox 13"/>
            <p:cNvSpPr txBox="1"/>
            <p:nvPr/>
          </p:nvSpPr>
          <p:spPr>
            <a:xfrm>
              <a:off x="4270537" y="685186"/>
              <a:ext cx="12311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Adipogenic</a:t>
              </a:r>
              <a:endParaRPr lang="nl-NL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660232" y="685186"/>
              <a:ext cx="1230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Osteogenic</a:t>
              </a:r>
              <a:endParaRPr lang="nl-NL" dirty="0"/>
            </a:p>
          </p:txBody>
        </p:sp>
        <p:pic>
          <p:nvPicPr>
            <p:cNvPr id="16" name="Picture 15" descr="C:\Users\marijnd\AppData\Local\Microsoft\Windows\INetCache\Content.Word\15 mono stain rand (3).jpg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69873" y="1078935"/>
              <a:ext cx="2160000" cy="162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" name="Picture 16" descr="C:\Users\marijnd\AppData\Local\Microsoft\Windows\INetCache\Content.Word\15 spinner 200x.jpg"/>
            <p:cNvPicPr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69873" y="2842127"/>
              <a:ext cx="2160000" cy="1656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" name="Picture 2" descr="15 scinus 200x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66476" y="4603191"/>
              <a:ext cx="2160000" cy="16099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6" name="TextBox 5"/>
          <p:cNvSpPr txBox="1"/>
          <p:nvPr/>
        </p:nvSpPr>
        <p:spPr>
          <a:xfrm rot="16200000">
            <a:off x="-1973563" y="3456229"/>
            <a:ext cx="517275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Donor 1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117991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899593" y="685186"/>
            <a:ext cx="6991489" cy="5114875"/>
            <a:chOff x="899593" y="685186"/>
            <a:chExt cx="6991489" cy="5114875"/>
          </a:xfrm>
        </p:grpSpPr>
        <p:sp>
          <p:nvSpPr>
            <p:cNvPr id="4" name="TextBox 3"/>
            <p:cNvSpPr txBox="1"/>
            <p:nvPr/>
          </p:nvSpPr>
          <p:spPr>
            <a:xfrm>
              <a:off x="1645850" y="692696"/>
              <a:ext cx="1488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Chondrogenic</a:t>
              </a:r>
              <a:endParaRPr lang="nl-NL" dirty="0"/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760292" y="1684947"/>
              <a:ext cx="6479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Flask</a:t>
              </a:r>
              <a:endParaRPr lang="nl-NL" dirty="0"/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632052" y="3457713"/>
              <a:ext cx="9044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smtClean="0"/>
                <a:t>Spinner</a:t>
              </a:r>
              <a:endParaRPr lang="nl-NL" dirty="0"/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696973" y="5228110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smtClean="0"/>
                <a:t>Scinus</a:t>
              </a:r>
              <a:endParaRPr lang="nl-NL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270537" y="685186"/>
              <a:ext cx="12311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Adipogenic</a:t>
              </a:r>
              <a:endParaRPr lang="nl-NL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660232" y="685186"/>
              <a:ext cx="1230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Osteogenic</a:t>
              </a:r>
              <a:endParaRPr lang="nl-NL" dirty="0"/>
            </a:p>
          </p:txBody>
        </p:sp>
      </p:grpSp>
      <p:sp>
        <p:nvSpPr>
          <p:cNvPr id="6" name="TextBox 5"/>
          <p:cNvSpPr txBox="1"/>
          <p:nvPr/>
        </p:nvSpPr>
        <p:spPr>
          <a:xfrm rot="16200000">
            <a:off x="-1973563" y="3456229"/>
            <a:ext cx="517275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Donor 2</a:t>
            </a:r>
            <a:endParaRPr lang="nl-NL" dirty="0"/>
          </a:p>
        </p:txBody>
      </p:sp>
      <p:pic>
        <p:nvPicPr>
          <p:cNvPr id="19" name="Picture 18" descr="C:\Users\marijnd\AppData\Local\Microsoft\Windows\INetCache\Content.Word\Adipo A4 200x (3).jpg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806090" y="1075080"/>
            <a:ext cx="2160000" cy="163584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2" descr="Adipo B1 200x (3)"/>
          <p:cNvPicPr>
            <a:picLocks noChangeAspect="1" noChangeArrowheads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806090" y="2910620"/>
            <a:ext cx="2160000" cy="1630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21" descr="C:\Users\marijnd\AppData\Local\Microsoft\Windows\INetCache\Content.Word\Adipo B2 200x (3).jpg"/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786989" y="4678703"/>
            <a:ext cx="2160000" cy="162222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3" descr="22M20161818bewerkt rens"/>
          <p:cNvPicPr>
            <a:picLocks noChangeAspect="1" noChangeArrowheads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356724" y="1117506"/>
            <a:ext cx="2160000" cy="162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4" descr="22SP20162404bewerkt rens"/>
          <p:cNvPicPr>
            <a:picLocks noChangeAspect="1" noChangeArrowheads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356724" y="2910620"/>
            <a:ext cx="2160000" cy="162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 descr="22SC21123650bewerkt rens"/>
          <p:cNvPicPr>
            <a:picLocks noChangeAspect="1" noChangeArrowheads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351817" y="4671735"/>
            <a:ext cx="2160000" cy="16167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25" descr="C:\Users\marijnd\AppData\Local\Microsoft\Windows\INetCache\Content.Word\22 scinus 200x (3).jpg"/>
          <p:cNvPicPr>
            <a:picLocks noChangeAspect="1"/>
          </p:cNvPicPr>
          <p:nvPr/>
        </p:nvPicPr>
        <p:blipFill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6195657" y="4645541"/>
            <a:ext cx="2160000" cy="1611545"/>
          </a:xfrm>
          <a:prstGeom prst="rect">
            <a:avLst/>
          </a:prstGeom>
          <a:noFill/>
          <a:ln>
            <a:noFill/>
          </a:ln>
        </p:spPr>
      </p:pic>
      <p:sp>
        <p:nvSpPr>
          <p:cNvPr id="27" name="TextBox 26"/>
          <p:cNvSpPr txBox="1"/>
          <p:nvPr/>
        </p:nvSpPr>
        <p:spPr>
          <a:xfrm>
            <a:off x="6570592" y="3485461"/>
            <a:ext cx="14101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 smtClean="0"/>
              <a:t>Not</a:t>
            </a:r>
            <a:r>
              <a:rPr lang="nl-NL" dirty="0" smtClean="0"/>
              <a:t> </a:t>
            </a:r>
            <a:r>
              <a:rPr lang="nl-NL" dirty="0" err="1" smtClean="0"/>
              <a:t>available</a:t>
            </a:r>
            <a:endParaRPr lang="nl-NL" dirty="0"/>
          </a:p>
        </p:txBody>
      </p:sp>
      <p:sp>
        <p:nvSpPr>
          <p:cNvPr id="28" name="TextBox 27"/>
          <p:cNvSpPr txBox="1"/>
          <p:nvPr/>
        </p:nvSpPr>
        <p:spPr>
          <a:xfrm>
            <a:off x="6570592" y="1684946"/>
            <a:ext cx="14101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 smtClean="0"/>
              <a:t>Not</a:t>
            </a:r>
            <a:r>
              <a:rPr lang="nl-NL" dirty="0" smtClean="0"/>
              <a:t> </a:t>
            </a:r>
            <a:r>
              <a:rPr lang="nl-NL" dirty="0" err="1" smtClean="0"/>
              <a:t>available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7324683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899593" y="685186"/>
            <a:ext cx="6991489" cy="5114875"/>
            <a:chOff x="899593" y="685186"/>
            <a:chExt cx="6991489" cy="5114875"/>
          </a:xfrm>
        </p:grpSpPr>
        <p:sp>
          <p:nvSpPr>
            <p:cNvPr id="4" name="TextBox 3"/>
            <p:cNvSpPr txBox="1"/>
            <p:nvPr/>
          </p:nvSpPr>
          <p:spPr>
            <a:xfrm>
              <a:off x="1645850" y="692696"/>
              <a:ext cx="1488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Chondrogenic</a:t>
              </a:r>
              <a:endParaRPr lang="nl-NL" dirty="0"/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760292" y="1684947"/>
              <a:ext cx="6479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Flask</a:t>
              </a:r>
              <a:endParaRPr lang="nl-NL" dirty="0"/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632052" y="3457713"/>
              <a:ext cx="9044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smtClean="0"/>
                <a:t>Spinner</a:t>
              </a:r>
              <a:endParaRPr lang="nl-NL" dirty="0"/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696973" y="5228110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smtClean="0"/>
                <a:t>Scinus</a:t>
              </a:r>
              <a:endParaRPr lang="nl-NL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270537" y="685186"/>
              <a:ext cx="12311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Adipogenic</a:t>
              </a:r>
              <a:endParaRPr lang="nl-NL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660232" y="685186"/>
              <a:ext cx="1230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Osteogenic</a:t>
              </a:r>
              <a:endParaRPr lang="nl-NL" dirty="0"/>
            </a:p>
          </p:txBody>
        </p:sp>
      </p:grpSp>
      <p:sp>
        <p:nvSpPr>
          <p:cNvPr id="6" name="TextBox 5"/>
          <p:cNvSpPr txBox="1"/>
          <p:nvPr/>
        </p:nvSpPr>
        <p:spPr>
          <a:xfrm rot="16200000">
            <a:off x="-1973563" y="3456229"/>
            <a:ext cx="517275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Donor 3</a:t>
            </a:r>
            <a:endParaRPr lang="nl-NL" dirty="0"/>
          </a:p>
        </p:txBody>
      </p:sp>
      <p:pic>
        <p:nvPicPr>
          <p:cNvPr id="19" name="Picture 18" descr="C:\Users\marijnd\AppData\Local\Microsoft\Windows\INetCache\Content.Word\Adipo B3 200x (4).jpg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806090" y="1105892"/>
            <a:ext cx="2160000" cy="1622007"/>
          </a:xfrm>
          <a:prstGeom prst="rect">
            <a:avLst/>
          </a:prstGeom>
          <a:noFill/>
          <a:ln>
            <a:noFill/>
          </a:ln>
        </p:spPr>
      </p:pic>
      <p:pic>
        <p:nvPicPr>
          <p:cNvPr id="2050" name="Picture 2" descr="Adipo B4 200x (3)"/>
          <p:cNvPicPr>
            <a:picLocks noChangeAspect="1" noChangeArrowheads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806090" y="2926779"/>
            <a:ext cx="2160000" cy="16231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 descr="Adipo C1 200x (4)"/>
          <p:cNvPicPr>
            <a:picLocks noChangeAspect="1" noChangeArrowheads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806090" y="4750809"/>
            <a:ext cx="2160000" cy="16186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 descr="59M20163054bewerkt rens"/>
          <p:cNvPicPr>
            <a:picLocks noChangeAspect="1" noChangeArrowheads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403648" y="1111142"/>
            <a:ext cx="2160000" cy="16167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3" name="Picture 5" descr="59SP20163606bewerkt rens"/>
          <p:cNvPicPr>
            <a:picLocks noChangeAspect="1" noChangeArrowheads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403648" y="2930436"/>
            <a:ext cx="2160000" cy="16081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4" name="Picture 6" descr="59SC20164150bewerkt rens"/>
          <p:cNvPicPr>
            <a:picLocks noChangeAspect="1" noChangeArrowheads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403648" y="4756059"/>
            <a:ext cx="2160000" cy="16054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25" descr="C:\Users\marijnd\AppData\Local\Microsoft\Windows\INetCache\Content.Word\59 mono 200x.jpg"/>
          <p:cNvPicPr>
            <a:picLocks noChangeAspect="1"/>
          </p:cNvPicPr>
          <p:nvPr/>
        </p:nvPicPr>
        <p:blipFill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6195657" y="1111142"/>
            <a:ext cx="2160000" cy="16318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056" name="Picture 8" descr="59SP12112905"/>
          <p:cNvPicPr>
            <a:picLocks noChangeAspect="1" noChangeArrowheads="1"/>
          </p:cNvPicPr>
          <p:nvPr/>
        </p:nvPicPr>
        <p:blipFill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6195657" y="2926779"/>
            <a:ext cx="2160000" cy="16232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27" descr="S:\02 Studies\2019\SSL-19-006 - Differentiation assays for manuscript of P16023\2. Report\Staining Osteo\06jun19 MDR - 25 27 28 days\59 scinus 200x.JPG"/>
          <p:cNvPicPr>
            <a:picLocks noChangeAspect="1"/>
          </p:cNvPicPr>
          <p:nvPr/>
        </p:nvPicPr>
        <p:blipFill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6216548" y="4756059"/>
            <a:ext cx="2160000" cy="162189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7324683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899593" y="685186"/>
            <a:ext cx="6991489" cy="5114875"/>
            <a:chOff x="899593" y="685186"/>
            <a:chExt cx="6991489" cy="5114875"/>
          </a:xfrm>
        </p:grpSpPr>
        <p:sp>
          <p:nvSpPr>
            <p:cNvPr id="4" name="TextBox 3"/>
            <p:cNvSpPr txBox="1"/>
            <p:nvPr/>
          </p:nvSpPr>
          <p:spPr>
            <a:xfrm>
              <a:off x="1645850" y="692696"/>
              <a:ext cx="1488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Chondrogenic</a:t>
              </a:r>
              <a:endParaRPr lang="nl-NL" dirty="0"/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760292" y="1684947"/>
              <a:ext cx="6479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Flask</a:t>
              </a:r>
              <a:endParaRPr lang="nl-NL" dirty="0"/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632052" y="3457713"/>
              <a:ext cx="9044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smtClean="0"/>
                <a:t>Spinner</a:t>
              </a:r>
              <a:endParaRPr lang="nl-NL" dirty="0"/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696973" y="5228110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smtClean="0"/>
                <a:t>Scinus</a:t>
              </a:r>
              <a:endParaRPr lang="nl-NL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270537" y="685186"/>
              <a:ext cx="12311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Adipogenic</a:t>
              </a:r>
              <a:endParaRPr lang="nl-NL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660232" y="685186"/>
              <a:ext cx="1230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Osteogenic</a:t>
              </a:r>
              <a:endParaRPr lang="nl-NL" dirty="0"/>
            </a:p>
          </p:txBody>
        </p:sp>
      </p:grpSp>
      <p:sp>
        <p:nvSpPr>
          <p:cNvPr id="6" name="TextBox 5"/>
          <p:cNvSpPr txBox="1"/>
          <p:nvPr/>
        </p:nvSpPr>
        <p:spPr>
          <a:xfrm rot="16200000">
            <a:off x="-1973563" y="3456229"/>
            <a:ext cx="517275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Donor 4</a:t>
            </a:r>
            <a:endParaRPr lang="nl-NL" dirty="0"/>
          </a:p>
        </p:txBody>
      </p:sp>
      <p:pic>
        <p:nvPicPr>
          <p:cNvPr id="19" name="Picture 18" descr="C:\Users\marijnd\AppData\Local\Microsoft\Windows\INetCache\Content.Word\Adipo C2 200x (3)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6090" y="1089066"/>
            <a:ext cx="2160000" cy="1635439"/>
          </a:xfrm>
          <a:prstGeom prst="rect">
            <a:avLst/>
          </a:prstGeom>
          <a:noFill/>
          <a:ln>
            <a:noFill/>
          </a:ln>
        </p:spPr>
      </p:pic>
      <p:pic>
        <p:nvPicPr>
          <p:cNvPr id="3074" name="Picture 2" descr="Adipo C3 200x (3)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1834" y="2881611"/>
            <a:ext cx="2160000" cy="16287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 descr="Adipo C4 200x (4)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6090" y="4622873"/>
            <a:ext cx="2160000" cy="15963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 descr="25M20164703bewerkt rens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0188" y="1073421"/>
            <a:ext cx="2160000" cy="16274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5" descr="25Sp20164942bewerkt rens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0188" y="2856049"/>
            <a:ext cx="2160000" cy="162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8" name="Picture 6" descr="25SC20165743bewerkt rens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0188" y="4622873"/>
            <a:ext cx="2160000" cy="16167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9" name="Picture 7" descr="25 mono 200x (2)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0191" y="1108068"/>
            <a:ext cx="2160000" cy="16262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25" descr="C:\Users\marijnd\AppData\Local\Microsoft\Windows\INetCache\Content.Word\TEST 25SC06120625.jpg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0191" y="4601459"/>
            <a:ext cx="2160000" cy="1622634"/>
          </a:xfrm>
          <a:prstGeom prst="rect">
            <a:avLst/>
          </a:prstGeom>
          <a:noFill/>
          <a:ln>
            <a:noFill/>
          </a:ln>
        </p:spPr>
      </p:pic>
      <p:sp>
        <p:nvSpPr>
          <p:cNvPr id="27" name="TextBox 26"/>
          <p:cNvSpPr txBox="1"/>
          <p:nvPr/>
        </p:nvSpPr>
        <p:spPr>
          <a:xfrm>
            <a:off x="6570592" y="3496202"/>
            <a:ext cx="14101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 smtClean="0"/>
              <a:t>Not</a:t>
            </a:r>
            <a:r>
              <a:rPr lang="nl-NL" dirty="0" smtClean="0"/>
              <a:t> </a:t>
            </a:r>
            <a:r>
              <a:rPr lang="nl-NL" dirty="0" err="1" smtClean="0"/>
              <a:t>available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7324683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899593" y="685186"/>
            <a:ext cx="6991489" cy="5114875"/>
            <a:chOff x="899593" y="685186"/>
            <a:chExt cx="6991489" cy="5114875"/>
          </a:xfrm>
        </p:grpSpPr>
        <p:sp>
          <p:nvSpPr>
            <p:cNvPr id="4" name="TextBox 3"/>
            <p:cNvSpPr txBox="1"/>
            <p:nvPr/>
          </p:nvSpPr>
          <p:spPr>
            <a:xfrm>
              <a:off x="1645850" y="692696"/>
              <a:ext cx="1488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Chondrogenic</a:t>
              </a:r>
              <a:endParaRPr lang="nl-NL" dirty="0"/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760292" y="1684947"/>
              <a:ext cx="6479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Flask</a:t>
              </a:r>
              <a:endParaRPr lang="nl-NL" dirty="0"/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632052" y="3457713"/>
              <a:ext cx="9044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smtClean="0"/>
                <a:t>Spinner</a:t>
              </a:r>
              <a:endParaRPr lang="nl-NL" dirty="0"/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696973" y="5228110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smtClean="0"/>
                <a:t>Scinus</a:t>
              </a:r>
              <a:endParaRPr lang="nl-NL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270537" y="685186"/>
              <a:ext cx="12311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Adipogenic</a:t>
              </a:r>
              <a:endParaRPr lang="nl-NL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660232" y="685186"/>
              <a:ext cx="1230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 smtClean="0"/>
                <a:t>Osteogenic</a:t>
              </a:r>
              <a:endParaRPr lang="nl-NL" dirty="0"/>
            </a:p>
          </p:txBody>
        </p:sp>
      </p:grpSp>
      <p:sp>
        <p:nvSpPr>
          <p:cNvPr id="6" name="TextBox 5"/>
          <p:cNvSpPr txBox="1"/>
          <p:nvPr/>
        </p:nvSpPr>
        <p:spPr>
          <a:xfrm rot="16200000">
            <a:off x="-1973563" y="3456229"/>
            <a:ext cx="517275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Donor 5</a:t>
            </a:r>
            <a:endParaRPr lang="nl-NL" dirty="0"/>
          </a:p>
        </p:txBody>
      </p:sp>
      <p:pic>
        <p:nvPicPr>
          <p:cNvPr id="4098" name="Picture 2" descr="0563111543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5002" y="1101764"/>
            <a:ext cx="2160000" cy="16207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 descr="Adipo pl 3 B3 200x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5002" y="4575778"/>
            <a:ext cx="2160000" cy="16167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4170143" y="3485461"/>
            <a:ext cx="14101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 smtClean="0"/>
              <a:t>Not</a:t>
            </a:r>
            <a:r>
              <a:rPr lang="nl-NL" dirty="0" smtClean="0"/>
              <a:t> </a:t>
            </a:r>
            <a:r>
              <a:rPr lang="nl-NL" dirty="0" err="1" smtClean="0"/>
              <a:t>available</a:t>
            </a:r>
            <a:endParaRPr lang="nl-NL" dirty="0"/>
          </a:p>
        </p:txBody>
      </p:sp>
      <p:pic>
        <p:nvPicPr>
          <p:cNvPr id="22" name="Picture 21" descr="C:\Users\marijnd\AppData\Local\Microsoft\Windows\INetCache\Content.Word\56SP20170130bewerkt rens.jp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3647" y="2806394"/>
            <a:ext cx="2160000" cy="1615688"/>
          </a:xfrm>
          <a:prstGeom prst="rect">
            <a:avLst/>
          </a:prstGeom>
          <a:noFill/>
          <a:ln>
            <a:noFill/>
          </a:ln>
        </p:spPr>
      </p:pic>
      <p:pic>
        <p:nvPicPr>
          <p:cNvPr id="4100" name="Picture 4" descr="56Sc20170729bewerkt rens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7114" y="4575778"/>
            <a:ext cx="2160000" cy="16230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1772049" y="1684946"/>
            <a:ext cx="14101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 smtClean="0"/>
              <a:t>Not</a:t>
            </a:r>
            <a:r>
              <a:rPr lang="nl-NL" dirty="0" smtClean="0"/>
              <a:t> </a:t>
            </a:r>
            <a:r>
              <a:rPr lang="nl-NL" dirty="0" err="1" smtClean="0"/>
              <a:t>available</a:t>
            </a:r>
            <a:endParaRPr lang="nl-NL" dirty="0"/>
          </a:p>
        </p:txBody>
      </p:sp>
      <p:pic>
        <p:nvPicPr>
          <p:cNvPr id="25" name="Picture 24" descr="S:\02 Studies\2019\SSL-19-006 - Differentiation assays for manuscript of P16023\2. Report\Staining Osteo\56SC09140337.JPG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5657" y="4576638"/>
            <a:ext cx="2160000" cy="1622171"/>
          </a:xfrm>
          <a:prstGeom prst="rect">
            <a:avLst/>
          </a:prstGeom>
          <a:noFill/>
          <a:ln>
            <a:noFill/>
          </a:ln>
        </p:spPr>
      </p:pic>
      <p:sp>
        <p:nvSpPr>
          <p:cNvPr id="26" name="TextBox 25"/>
          <p:cNvSpPr txBox="1"/>
          <p:nvPr/>
        </p:nvSpPr>
        <p:spPr>
          <a:xfrm>
            <a:off x="6570592" y="3424686"/>
            <a:ext cx="14101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 smtClean="0"/>
              <a:t>Not</a:t>
            </a:r>
            <a:r>
              <a:rPr lang="nl-NL" dirty="0" smtClean="0"/>
              <a:t> </a:t>
            </a:r>
            <a:r>
              <a:rPr lang="nl-NL" dirty="0" err="1" smtClean="0"/>
              <a:t>available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7324683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3</TotalTime>
  <Words>52</Words>
  <Application>Microsoft Office PowerPoint</Application>
  <PresentationFormat>On-screen Show (4:3)</PresentationFormat>
  <Paragraphs>41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Xpand-biote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ud Das</dc:creator>
  <cp:lastModifiedBy>Ruud Das</cp:lastModifiedBy>
  <cp:revision>8</cp:revision>
  <dcterms:created xsi:type="dcterms:W3CDTF">2019-06-05T10:02:41Z</dcterms:created>
  <dcterms:modified xsi:type="dcterms:W3CDTF">2019-06-12T15:34:48Z</dcterms:modified>
</cp:coreProperties>
</file>